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659563" cy="2808288"/>
  <p:notesSz cx="6858000" cy="9144000"/>
  <p:defaultTextStyle>
    <a:defPPr>
      <a:defRPr lang="en-US"/>
    </a:defPPr>
    <a:lvl1pPr marL="0" algn="l" defTabSz="454457" rtl="0" eaLnBrk="1" latinLnBrk="0" hangingPunct="1">
      <a:defRPr sz="895" kern="1200">
        <a:solidFill>
          <a:schemeClr val="tx1"/>
        </a:solidFill>
        <a:latin typeface="+mn-lt"/>
        <a:ea typeface="+mn-ea"/>
        <a:cs typeface="+mn-cs"/>
      </a:defRPr>
    </a:lvl1pPr>
    <a:lvl2pPr marL="227228" algn="l" defTabSz="454457" rtl="0" eaLnBrk="1" latinLnBrk="0" hangingPunct="1">
      <a:defRPr sz="895" kern="1200">
        <a:solidFill>
          <a:schemeClr val="tx1"/>
        </a:solidFill>
        <a:latin typeface="+mn-lt"/>
        <a:ea typeface="+mn-ea"/>
        <a:cs typeface="+mn-cs"/>
      </a:defRPr>
    </a:lvl2pPr>
    <a:lvl3pPr marL="454457" algn="l" defTabSz="454457" rtl="0" eaLnBrk="1" latinLnBrk="0" hangingPunct="1">
      <a:defRPr sz="895" kern="1200">
        <a:solidFill>
          <a:schemeClr val="tx1"/>
        </a:solidFill>
        <a:latin typeface="+mn-lt"/>
        <a:ea typeface="+mn-ea"/>
        <a:cs typeface="+mn-cs"/>
      </a:defRPr>
    </a:lvl3pPr>
    <a:lvl4pPr marL="681685" algn="l" defTabSz="454457" rtl="0" eaLnBrk="1" latinLnBrk="0" hangingPunct="1">
      <a:defRPr sz="895" kern="1200">
        <a:solidFill>
          <a:schemeClr val="tx1"/>
        </a:solidFill>
        <a:latin typeface="+mn-lt"/>
        <a:ea typeface="+mn-ea"/>
        <a:cs typeface="+mn-cs"/>
      </a:defRPr>
    </a:lvl4pPr>
    <a:lvl5pPr marL="908914" algn="l" defTabSz="454457" rtl="0" eaLnBrk="1" latinLnBrk="0" hangingPunct="1">
      <a:defRPr sz="895" kern="1200">
        <a:solidFill>
          <a:schemeClr val="tx1"/>
        </a:solidFill>
        <a:latin typeface="+mn-lt"/>
        <a:ea typeface="+mn-ea"/>
        <a:cs typeface="+mn-cs"/>
      </a:defRPr>
    </a:lvl5pPr>
    <a:lvl6pPr marL="1136142" algn="l" defTabSz="454457" rtl="0" eaLnBrk="1" latinLnBrk="0" hangingPunct="1">
      <a:defRPr sz="895" kern="1200">
        <a:solidFill>
          <a:schemeClr val="tx1"/>
        </a:solidFill>
        <a:latin typeface="+mn-lt"/>
        <a:ea typeface="+mn-ea"/>
        <a:cs typeface="+mn-cs"/>
      </a:defRPr>
    </a:lvl6pPr>
    <a:lvl7pPr marL="1363370" algn="l" defTabSz="454457" rtl="0" eaLnBrk="1" latinLnBrk="0" hangingPunct="1">
      <a:defRPr sz="895" kern="1200">
        <a:solidFill>
          <a:schemeClr val="tx1"/>
        </a:solidFill>
        <a:latin typeface="+mn-lt"/>
        <a:ea typeface="+mn-ea"/>
        <a:cs typeface="+mn-cs"/>
      </a:defRPr>
    </a:lvl7pPr>
    <a:lvl8pPr marL="1590599" algn="l" defTabSz="454457" rtl="0" eaLnBrk="1" latinLnBrk="0" hangingPunct="1">
      <a:defRPr sz="895" kern="1200">
        <a:solidFill>
          <a:schemeClr val="tx1"/>
        </a:solidFill>
        <a:latin typeface="+mn-lt"/>
        <a:ea typeface="+mn-ea"/>
        <a:cs typeface="+mn-cs"/>
      </a:defRPr>
    </a:lvl8pPr>
    <a:lvl9pPr marL="1817827" algn="l" defTabSz="454457" rtl="0" eaLnBrk="1" latinLnBrk="0" hangingPunct="1">
      <a:defRPr sz="895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56" d="100"/>
          <a:sy n="156" d="100"/>
        </p:scale>
        <p:origin x="138" y="19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F:\Field\2019\&#20108;&#31295;\New%20folder\&#25913;2\EPI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2!$B$1</c:f>
              <c:strCache>
                <c:ptCount val="1"/>
                <c:pt idx="0">
                  <c:v>RIL</c:v>
                </c:pt>
              </c:strCache>
            </c:strRef>
          </c:tx>
          <c:spPr>
            <a:solidFill>
              <a:srgbClr val="00B050"/>
            </a:solidFill>
            <a:ln>
              <a:noFill/>
            </a:ln>
            <a:effectLst/>
          </c:spPr>
          <c:invertIfNegative val="0"/>
          <c:cat>
            <c:strRef>
              <c:f>Sheet2!$A$2:$A$19</c:f>
              <c:strCache>
                <c:ptCount val="18"/>
                <c:pt idx="0">
                  <c:v>EWPE</c:v>
                </c:pt>
                <c:pt idx="1">
                  <c:v>EWPE-Epi</c:v>
                </c:pt>
                <c:pt idx="2">
                  <c:v>CWPE</c:v>
                </c:pt>
                <c:pt idx="3">
                  <c:v>CWPE-Epi</c:v>
                </c:pt>
                <c:pt idx="4">
                  <c:v>EL</c:v>
                </c:pt>
                <c:pt idx="5">
                  <c:v>EL-Epi</c:v>
                </c:pt>
                <c:pt idx="6">
                  <c:v>ED</c:v>
                </c:pt>
                <c:pt idx="7">
                  <c:v>ED-Epi</c:v>
                </c:pt>
                <c:pt idx="8">
                  <c:v>CD</c:v>
                </c:pt>
                <c:pt idx="9">
                  <c:v>CD-Epi</c:v>
                </c:pt>
                <c:pt idx="10">
                  <c:v>RN</c:v>
                </c:pt>
                <c:pt idx="11">
                  <c:v>RN-Epi</c:v>
                </c:pt>
                <c:pt idx="12">
                  <c:v>KNPR</c:v>
                </c:pt>
                <c:pt idx="13">
                  <c:v>KNPR-Epi</c:v>
                </c:pt>
                <c:pt idx="14">
                  <c:v>KWPE</c:v>
                </c:pt>
                <c:pt idx="15">
                  <c:v>KWPE-Epi</c:v>
                </c:pt>
                <c:pt idx="16">
                  <c:v>RKP</c:v>
                </c:pt>
                <c:pt idx="17">
                  <c:v>RKP-Epi</c:v>
                </c:pt>
              </c:strCache>
            </c:strRef>
          </c:cat>
          <c:val>
            <c:numRef>
              <c:f>Sheet2!$B$2:$B$19</c:f>
              <c:numCache>
                <c:formatCode>General</c:formatCode>
                <c:ptCount val="18"/>
                <c:pt idx="0">
                  <c:v>6.3</c:v>
                </c:pt>
                <c:pt idx="2">
                  <c:v>38.9</c:v>
                </c:pt>
                <c:pt idx="3">
                  <c:v>4.8573000000000004</c:v>
                </c:pt>
                <c:pt idx="4">
                  <c:v>37.6</c:v>
                </c:pt>
                <c:pt idx="6">
                  <c:v>28.6</c:v>
                </c:pt>
                <c:pt idx="8">
                  <c:v>28.8</c:v>
                </c:pt>
                <c:pt idx="10">
                  <c:v>45.2</c:v>
                </c:pt>
                <c:pt idx="12">
                  <c:v>26</c:v>
                </c:pt>
                <c:pt idx="14">
                  <c:v>20.100000000000001</c:v>
                </c:pt>
                <c:pt idx="15">
                  <c:v>8.4824999999999999</c:v>
                </c:pt>
                <c:pt idx="16">
                  <c:v>38.4</c:v>
                </c:pt>
              </c:numCache>
            </c:numRef>
          </c:val>
        </c:ser>
        <c:ser>
          <c:idx val="1"/>
          <c:order val="1"/>
          <c:tx>
            <c:strRef>
              <c:f>Sheet2!$C$1</c:f>
              <c:strCache>
                <c:ptCount val="1"/>
                <c:pt idx="0">
                  <c:v>IF2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cat>
            <c:strRef>
              <c:f>Sheet2!$A$2:$A$19</c:f>
              <c:strCache>
                <c:ptCount val="18"/>
                <c:pt idx="0">
                  <c:v>EWPE</c:v>
                </c:pt>
                <c:pt idx="1">
                  <c:v>EWPE-Epi</c:v>
                </c:pt>
                <c:pt idx="2">
                  <c:v>CWPE</c:v>
                </c:pt>
                <c:pt idx="3">
                  <c:v>CWPE-Epi</c:v>
                </c:pt>
                <c:pt idx="4">
                  <c:v>EL</c:v>
                </c:pt>
                <c:pt idx="5">
                  <c:v>EL-Epi</c:v>
                </c:pt>
                <c:pt idx="6">
                  <c:v>ED</c:v>
                </c:pt>
                <c:pt idx="7">
                  <c:v>ED-Epi</c:v>
                </c:pt>
                <c:pt idx="8">
                  <c:v>CD</c:v>
                </c:pt>
                <c:pt idx="9">
                  <c:v>CD-Epi</c:v>
                </c:pt>
                <c:pt idx="10">
                  <c:v>RN</c:v>
                </c:pt>
                <c:pt idx="11">
                  <c:v>RN-Epi</c:v>
                </c:pt>
                <c:pt idx="12">
                  <c:v>KNPR</c:v>
                </c:pt>
                <c:pt idx="13">
                  <c:v>KNPR-Epi</c:v>
                </c:pt>
                <c:pt idx="14">
                  <c:v>KWPE</c:v>
                </c:pt>
                <c:pt idx="15">
                  <c:v>KWPE-Epi</c:v>
                </c:pt>
                <c:pt idx="16">
                  <c:v>RKP</c:v>
                </c:pt>
                <c:pt idx="17">
                  <c:v>RKP-Epi</c:v>
                </c:pt>
              </c:strCache>
            </c:strRef>
          </c:cat>
          <c:val>
            <c:numRef>
              <c:f>Sheet2!$C$2:$C$19</c:f>
              <c:numCache>
                <c:formatCode>General</c:formatCode>
                <c:ptCount val="18"/>
                <c:pt idx="0">
                  <c:v>48.4</c:v>
                </c:pt>
                <c:pt idx="1">
                  <c:v>47.592800000000004</c:v>
                </c:pt>
                <c:pt idx="2">
                  <c:v>40.5</c:v>
                </c:pt>
                <c:pt idx="3">
                  <c:v>50.312800000000003</c:v>
                </c:pt>
                <c:pt idx="4">
                  <c:v>43.6</c:v>
                </c:pt>
                <c:pt idx="5">
                  <c:v>37.231000000000002</c:v>
                </c:pt>
                <c:pt idx="6">
                  <c:v>23.6</c:v>
                </c:pt>
                <c:pt idx="7">
                  <c:v>29.679599999999994</c:v>
                </c:pt>
                <c:pt idx="8">
                  <c:v>31.9</c:v>
                </c:pt>
                <c:pt idx="9">
                  <c:v>55.946499999999993</c:v>
                </c:pt>
                <c:pt idx="10">
                  <c:v>44.9</c:v>
                </c:pt>
                <c:pt idx="11">
                  <c:v>37.738200000000006</c:v>
                </c:pt>
                <c:pt idx="12">
                  <c:v>37.1</c:v>
                </c:pt>
                <c:pt idx="13">
                  <c:v>52.976500000000009</c:v>
                </c:pt>
                <c:pt idx="14">
                  <c:v>38.799999999999997</c:v>
                </c:pt>
                <c:pt idx="15">
                  <c:v>31.7651</c:v>
                </c:pt>
                <c:pt idx="16">
                  <c:v>21.2</c:v>
                </c:pt>
                <c:pt idx="17">
                  <c:v>19.896799999999999</c:v>
                </c:pt>
              </c:numCache>
            </c:numRef>
          </c:val>
        </c:ser>
        <c:ser>
          <c:idx val="2"/>
          <c:order val="2"/>
          <c:tx>
            <c:strRef>
              <c:f>Sheet2!$D$1</c:f>
              <c:strCache>
                <c:ptCount val="1"/>
                <c:pt idx="0">
                  <c:v>MPH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f>Sheet2!$A$2:$A$19</c:f>
              <c:strCache>
                <c:ptCount val="18"/>
                <c:pt idx="0">
                  <c:v>EWPE</c:v>
                </c:pt>
                <c:pt idx="1">
                  <c:v>EWPE-Epi</c:v>
                </c:pt>
                <c:pt idx="2">
                  <c:v>CWPE</c:v>
                </c:pt>
                <c:pt idx="3">
                  <c:v>CWPE-Epi</c:v>
                </c:pt>
                <c:pt idx="4">
                  <c:v>EL</c:v>
                </c:pt>
                <c:pt idx="5">
                  <c:v>EL-Epi</c:v>
                </c:pt>
                <c:pt idx="6">
                  <c:v>ED</c:v>
                </c:pt>
                <c:pt idx="7">
                  <c:v>ED-Epi</c:v>
                </c:pt>
                <c:pt idx="8">
                  <c:v>CD</c:v>
                </c:pt>
                <c:pt idx="9">
                  <c:v>CD-Epi</c:v>
                </c:pt>
                <c:pt idx="10">
                  <c:v>RN</c:v>
                </c:pt>
                <c:pt idx="11">
                  <c:v>RN-Epi</c:v>
                </c:pt>
                <c:pt idx="12">
                  <c:v>KNPR</c:v>
                </c:pt>
                <c:pt idx="13">
                  <c:v>KNPR-Epi</c:v>
                </c:pt>
                <c:pt idx="14">
                  <c:v>KWPE</c:v>
                </c:pt>
                <c:pt idx="15">
                  <c:v>KWPE-Epi</c:v>
                </c:pt>
                <c:pt idx="16">
                  <c:v>RKP</c:v>
                </c:pt>
                <c:pt idx="17">
                  <c:v>RKP-Epi</c:v>
                </c:pt>
              </c:strCache>
            </c:strRef>
          </c:cat>
          <c:val>
            <c:numRef>
              <c:f>Sheet2!$D$2:$D$19</c:f>
              <c:numCache>
                <c:formatCode>General</c:formatCode>
                <c:ptCount val="18"/>
                <c:pt idx="0">
                  <c:v>48.5</c:v>
                </c:pt>
                <c:pt idx="1">
                  <c:v>20.217300000000002</c:v>
                </c:pt>
                <c:pt idx="2">
                  <c:v>28.3</c:v>
                </c:pt>
                <c:pt idx="3">
                  <c:v>22.629800000000003</c:v>
                </c:pt>
                <c:pt idx="4">
                  <c:v>23.6</c:v>
                </c:pt>
                <c:pt idx="5">
                  <c:v>61.403199999999998</c:v>
                </c:pt>
                <c:pt idx="6">
                  <c:v>18.7</c:v>
                </c:pt>
                <c:pt idx="7">
                  <c:v>50.5702</c:v>
                </c:pt>
                <c:pt idx="8">
                  <c:v>10.5</c:v>
                </c:pt>
                <c:pt idx="9">
                  <c:v>30.551000000000002</c:v>
                </c:pt>
                <c:pt idx="10">
                  <c:v>6.6</c:v>
                </c:pt>
                <c:pt idx="11">
                  <c:v>35.93</c:v>
                </c:pt>
                <c:pt idx="12">
                  <c:v>25</c:v>
                </c:pt>
                <c:pt idx="13">
                  <c:v>35.826999999999998</c:v>
                </c:pt>
                <c:pt idx="14">
                  <c:v>51.6</c:v>
                </c:pt>
                <c:pt idx="15">
                  <c:v>42.752600000000001</c:v>
                </c:pt>
                <c:pt idx="16">
                  <c:v>42.7</c:v>
                </c:pt>
                <c:pt idx="17">
                  <c:v>16.02720000000000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29901672"/>
        <c:axId val="329902064"/>
      </c:barChart>
      <c:catAx>
        <c:axId val="32990167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329902064"/>
        <c:crosses val="autoZero"/>
        <c:auto val="1"/>
        <c:lblAlgn val="ctr"/>
        <c:lblOffset val="100"/>
        <c:noMultiLvlLbl val="0"/>
      </c:catAx>
      <c:valAx>
        <c:axId val="329902064"/>
        <c:scaling>
          <c:orientation val="minMax"/>
          <c:max val="70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zh-CN"/>
                  <a:t>PVE(%)</a:t>
                </a:r>
                <a:endParaRPr lang="zh-CN" altLang="en-US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accent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329901672"/>
        <c:crosses val="autoZero"/>
        <c:crossBetween val="between"/>
        <c:majorUnit val="10"/>
        <c:minorUnit val="5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200" b="1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32446" y="459597"/>
            <a:ext cx="4994672" cy="977700"/>
          </a:xfrm>
        </p:spPr>
        <p:txBody>
          <a:bodyPr anchor="b"/>
          <a:lstStyle>
            <a:lvl1pPr algn="ctr">
              <a:defRPr sz="2457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32446" y="1475002"/>
            <a:ext cx="4994672" cy="678019"/>
          </a:xfrm>
        </p:spPr>
        <p:txBody>
          <a:bodyPr/>
          <a:lstStyle>
            <a:lvl1pPr marL="0" indent="0" algn="ctr">
              <a:buNone/>
              <a:defRPr sz="983"/>
            </a:lvl1pPr>
            <a:lvl2pPr marL="187223" indent="0" algn="ctr">
              <a:buNone/>
              <a:defRPr sz="819"/>
            </a:lvl2pPr>
            <a:lvl3pPr marL="374447" indent="0" algn="ctr">
              <a:buNone/>
              <a:defRPr sz="737"/>
            </a:lvl3pPr>
            <a:lvl4pPr marL="561670" indent="0" algn="ctr">
              <a:buNone/>
              <a:defRPr sz="655"/>
            </a:lvl4pPr>
            <a:lvl5pPr marL="748894" indent="0" algn="ctr">
              <a:buNone/>
              <a:defRPr sz="655"/>
            </a:lvl5pPr>
            <a:lvl6pPr marL="936117" indent="0" algn="ctr">
              <a:buNone/>
              <a:defRPr sz="655"/>
            </a:lvl6pPr>
            <a:lvl7pPr marL="1123340" indent="0" algn="ctr">
              <a:buNone/>
              <a:defRPr sz="655"/>
            </a:lvl7pPr>
            <a:lvl8pPr marL="1310564" indent="0" algn="ctr">
              <a:buNone/>
              <a:defRPr sz="655"/>
            </a:lvl8pPr>
            <a:lvl9pPr marL="1497787" indent="0" algn="ctr">
              <a:buNone/>
              <a:defRPr sz="655"/>
            </a:lvl9pPr>
          </a:lstStyle>
          <a:p>
            <a:r>
              <a:rPr lang="zh-CN" altLang="en-US" smtClean="0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F5696F-8095-42A1-BC0E-5FCF867847FE}" type="datetimeFigureOut">
              <a:rPr lang="en-GB" smtClean="0"/>
              <a:t>31/03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11F4F-98CD-4240-8D88-1FB301D7046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491913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F5696F-8095-42A1-BC0E-5FCF867847FE}" type="datetimeFigureOut">
              <a:rPr lang="en-GB" smtClean="0"/>
              <a:t>31/03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11F4F-98CD-4240-8D88-1FB301D7046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734159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765750" y="149515"/>
            <a:ext cx="1435968" cy="2379894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845" y="149515"/>
            <a:ext cx="4224660" cy="2379894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F5696F-8095-42A1-BC0E-5FCF867847FE}" type="datetimeFigureOut">
              <a:rPr lang="en-GB" smtClean="0"/>
              <a:t>31/03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11F4F-98CD-4240-8D88-1FB301D7046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810190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F5696F-8095-42A1-BC0E-5FCF867847FE}" type="datetimeFigureOut">
              <a:rPr lang="en-GB" smtClean="0"/>
              <a:t>31/03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11F4F-98CD-4240-8D88-1FB301D7046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789287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4376" y="700122"/>
            <a:ext cx="5743873" cy="1168170"/>
          </a:xfrm>
        </p:spPr>
        <p:txBody>
          <a:bodyPr anchor="b"/>
          <a:lstStyle>
            <a:lvl1pPr>
              <a:defRPr sz="2457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4376" y="1879343"/>
            <a:ext cx="5743873" cy="614313"/>
          </a:xfrm>
        </p:spPr>
        <p:txBody>
          <a:bodyPr/>
          <a:lstStyle>
            <a:lvl1pPr marL="0" indent="0">
              <a:buNone/>
              <a:defRPr sz="983">
                <a:solidFill>
                  <a:schemeClr val="tx1">
                    <a:tint val="75000"/>
                  </a:schemeClr>
                </a:solidFill>
              </a:defRPr>
            </a:lvl1pPr>
            <a:lvl2pPr marL="187223" indent="0">
              <a:buNone/>
              <a:defRPr sz="819">
                <a:solidFill>
                  <a:schemeClr val="tx1">
                    <a:tint val="75000"/>
                  </a:schemeClr>
                </a:solidFill>
              </a:defRPr>
            </a:lvl2pPr>
            <a:lvl3pPr marL="374447" indent="0">
              <a:buNone/>
              <a:defRPr sz="737">
                <a:solidFill>
                  <a:schemeClr val="tx1">
                    <a:tint val="75000"/>
                  </a:schemeClr>
                </a:solidFill>
              </a:defRPr>
            </a:lvl3pPr>
            <a:lvl4pPr marL="561670" indent="0">
              <a:buNone/>
              <a:defRPr sz="655">
                <a:solidFill>
                  <a:schemeClr val="tx1">
                    <a:tint val="75000"/>
                  </a:schemeClr>
                </a:solidFill>
              </a:defRPr>
            </a:lvl4pPr>
            <a:lvl5pPr marL="748894" indent="0">
              <a:buNone/>
              <a:defRPr sz="655">
                <a:solidFill>
                  <a:schemeClr val="tx1">
                    <a:tint val="75000"/>
                  </a:schemeClr>
                </a:solidFill>
              </a:defRPr>
            </a:lvl5pPr>
            <a:lvl6pPr marL="936117" indent="0">
              <a:buNone/>
              <a:defRPr sz="655">
                <a:solidFill>
                  <a:schemeClr val="tx1">
                    <a:tint val="75000"/>
                  </a:schemeClr>
                </a:solidFill>
              </a:defRPr>
            </a:lvl6pPr>
            <a:lvl7pPr marL="1123340" indent="0">
              <a:buNone/>
              <a:defRPr sz="655">
                <a:solidFill>
                  <a:schemeClr val="tx1">
                    <a:tint val="75000"/>
                  </a:schemeClr>
                </a:solidFill>
              </a:defRPr>
            </a:lvl7pPr>
            <a:lvl8pPr marL="1310564" indent="0">
              <a:buNone/>
              <a:defRPr sz="655">
                <a:solidFill>
                  <a:schemeClr val="tx1">
                    <a:tint val="75000"/>
                  </a:schemeClr>
                </a:solidFill>
              </a:defRPr>
            </a:lvl8pPr>
            <a:lvl9pPr marL="1497787" indent="0">
              <a:buNone/>
              <a:defRPr sz="65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F5696F-8095-42A1-BC0E-5FCF867847FE}" type="datetimeFigureOut">
              <a:rPr lang="en-GB" smtClean="0"/>
              <a:t>31/03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11F4F-98CD-4240-8D88-1FB301D7046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7277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845" y="747577"/>
            <a:ext cx="2830314" cy="1781833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371404" y="747577"/>
            <a:ext cx="2830314" cy="1781833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F5696F-8095-42A1-BC0E-5FCF867847FE}" type="datetimeFigureOut">
              <a:rPr lang="en-GB" smtClean="0"/>
              <a:t>31/03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11F4F-98CD-4240-8D88-1FB301D7046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452935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8712" y="149515"/>
            <a:ext cx="5743873" cy="542806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8713" y="688421"/>
            <a:ext cx="2817307" cy="337384"/>
          </a:xfrm>
        </p:spPr>
        <p:txBody>
          <a:bodyPr anchor="b"/>
          <a:lstStyle>
            <a:lvl1pPr marL="0" indent="0">
              <a:buNone/>
              <a:defRPr sz="983" b="1"/>
            </a:lvl1pPr>
            <a:lvl2pPr marL="187223" indent="0">
              <a:buNone/>
              <a:defRPr sz="819" b="1"/>
            </a:lvl2pPr>
            <a:lvl3pPr marL="374447" indent="0">
              <a:buNone/>
              <a:defRPr sz="737" b="1"/>
            </a:lvl3pPr>
            <a:lvl4pPr marL="561670" indent="0">
              <a:buNone/>
              <a:defRPr sz="655" b="1"/>
            </a:lvl4pPr>
            <a:lvl5pPr marL="748894" indent="0">
              <a:buNone/>
              <a:defRPr sz="655" b="1"/>
            </a:lvl5pPr>
            <a:lvl6pPr marL="936117" indent="0">
              <a:buNone/>
              <a:defRPr sz="655" b="1"/>
            </a:lvl6pPr>
            <a:lvl7pPr marL="1123340" indent="0">
              <a:buNone/>
              <a:defRPr sz="655" b="1"/>
            </a:lvl7pPr>
            <a:lvl8pPr marL="1310564" indent="0">
              <a:buNone/>
              <a:defRPr sz="655" b="1"/>
            </a:lvl8pPr>
            <a:lvl9pPr marL="1497787" indent="0">
              <a:buNone/>
              <a:defRPr sz="655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8713" y="1025805"/>
            <a:ext cx="2817307" cy="1508805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371404" y="688421"/>
            <a:ext cx="2831182" cy="337384"/>
          </a:xfrm>
        </p:spPr>
        <p:txBody>
          <a:bodyPr anchor="b"/>
          <a:lstStyle>
            <a:lvl1pPr marL="0" indent="0">
              <a:buNone/>
              <a:defRPr sz="983" b="1"/>
            </a:lvl1pPr>
            <a:lvl2pPr marL="187223" indent="0">
              <a:buNone/>
              <a:defRPr sz="819" b="1"/>
            </a:lvl2pPr>
            <a:lvl3pPr marL="374447" indent="0">
              <a:buNone/>
              <a:defRPr sz="737" b="1"/>
            </a:lvl3pPr>
            <a:lvl4pPr marL="561670" indent="0">
              <a:buNone/>
              <a:defRPr sz="655" b="1"/>
            </a:lvl4pPr>
            <a:lvl5pPr marL="748894" indent="0">
              <a:buNone/>
              <a:defRPr sz="655" b="1"/>
            </a:lvl5pPr>
            <a:lvl6pPr marL="936117" indent="0">
              <a:buNone/>
              <a:defRPr sz="655" b="1"/>
            </a:lvl6pPr>
            <a:lvl7pPr marL="1123340" indent="0">
              <a:buNone/>
              <a:defRPr sz="655" b="1"/>
            </a:lvl7pPr>
            <a:lvl8pPr marL="1310564" indent="0">
              <a:buNone/>
              <a:defRPr sz="655" b="1"/>
            </a:lvl8pPr>
            <a:lvl9pPr marL="1497787" indent="0">
              <a:buNone/>
              <a:defRPr sz="655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371404" y="1025805"/>
            <a:ext cx="2831182" cy="1508805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F5696F-8095-42A1-BC0E-5FCF867847FE}" type="datetimeFigureOut">
              <a:rPr lang="en-GB" smtClean="0"/>
              <a:t>31/03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11F4F-98CD-4240-8D88-1FB301D7046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85896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F5696F-8095-42A1-BC0E-5FCF867847FE}" type="datetimeFigureOut">
              <a:rPr lang="en-GB" smtClean="0"/>
              <a:t>31/03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11F4F-98CD-4240-8D88-1FB301D7046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975959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F5696F-8095-42A1-BC0E-5FCF867847FE}" type="datetimeFigureOut">
              <a:rPr lang="en-GB" smtClean="0"/>
              <a:t>31/03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11F4F-98CD-4240-8D88-1FB301D7046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37262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8713" y="187219"/>
            <a:ext cx="2147882" cy="655267"/>
          </a:xfrm>
        </p:spPr>
        <p:txBody>
          <a:bodyPr anchor="b"/>
          <a:lstStyle>
            <a:lvl1pPr>
              <a:defRPr sz="131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831182" y="404342"/>
            <a:ext cx="3371404" cy="1995705"/>
          </a:xfrm>
        </p:spPr>
        <p:txBody>
          <a:bodyPr/>
          <a:lstStyle>
            <a:lvl1pPr>
              <a:defRPr sz="1310"/>
            </a:lvl1pPr>
            <a:lvl2pPr>
              <a:defRPr sz="1147"/>
            </a:lvl2pPr>
            <a:lvl3pPr>
              <a:defRPr sz="983"/>
            </a:lvl3pPr>
            <a:lvl4pPr>
              <a:defRPr sz="819"/>
            </a:lvl4pPr>
            <a:lvl5pPr>
              <a:defRPr sz="819"/>
            </a:lvl5pPr>
            <a:lvl6pPr>
              <a:defRPr sz="819"/>
            </a:lvl6pPr>
            <a:lvl7pPr>
              <a:defRPr sz="819"/>
            </a:lvl7pPr>
            <a:lvl8pPr>
              <a:defRPr sz="819"/>
            </a:lvl8pPr>
            <a:lvl9pPr>
              <a:defRPr sz="819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8713" y="842487"/>
            <a:ext cx="2147882" cy="1560810"/>
          </a:xfrm>
        </p:spPr>
        <p:txBody>
          <a:bodyPr/>
          <a:lstStyle>
            <a:lvl1pPr marL="0" indent="0">
              <a:buNone/>
              <a:defRPr sz="655"/>
            </a:lvl1pPr>
            <a:lvl2pPr marL="187223" indent="0">
              <a:buNone/>
              <a:defRPr sz="573"/>
            </a:lvl2pPr>
            <a:lvl3pPr marL="374447" indent="0">
              <a:buNone/>
              <a:defRPr sz="491"/>
            </a:lvl3pPr>
            <a:lvl4pPr marL="561670" indent="0">
              <a:buNone/>
              <a:defRPr sz="410"/>
            </a:lvl4pPr>
            <a:lvl5pPr marL="748894" indent="0">
              <a:buNone/>
              <a:defRPr sz="410"/>
            </a:lvl5pPr>
            <a:lvl6pPr marL="936117" indent="0">
              <a:buNone/>
              <a:defRPr sz="410"/>
            </a:lvl6pPr>
            <a:lvl7pPr marL="1123340" indent="0">
              <a:buNone/>
              <a:defRPr sz="410"/>
            </a:lvl7pPr>
            <a:lvl8pPr marL="1310564" indent="0">
              <a:buNone/>
              <a:defRPr sz="410"/>
            </a:lvl8pPr>
            <a:lvl9pPr marL="1497787" indent="0">
              <a:buNone/>
              <a:defRPr sz="41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F5696F-8095-42A1-BC0E-5FCF867847FE}" type="datetimeFigureOut">
              <a:rPr lang="en-GB" smtClean="0"/>
              <a:t>31/03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11F4F-98CD-4240-8D88-1FB301D7046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059787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8713" y="187219"/>
            <a:ext cx="2147882" cy="655267"/>
          </a:xfrm>
        </p:spPr>
        <p:txBody>
          <a:bodyPr anchor="b"/>
          <a:lstStyle>
            <a:lvl1pPr>
              <a:defRPr sz="131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831182" y="404342"/>
            <a:ext cx="3371404" cy="1995705"/>
          </a:xfrm>
        </p:spPr>
        <p:txBody>
          <a:bodyPr anchor="t"/>
          <a:lstStyle>
            <a:lvl1pPr marL="0" indent="0">
              <a:buNone/>
              <a:defRPr sz="1310"/>
            </a:lvl1pPr>
            <a:lvl2pPr marL="187223" indent="0">
              <a:buNone/>
              <a:defRPr sz="1147"/>
            </a:lvl2pPr>
            <a:lvl3pPr marL="374447" indent="0">
              <a:buNone/>
              <a:defRPr sz="983"/>
            </a:lvl3pPr>
            <a:lvl4pPr marL="561670" indent="0">
              <a:buNone/>
              <a:defRPr sz="819"/>
            </a:lvl4pPr>
            <a:lvl5pPr marL="748894" indent="0">
              <a:buNone/>
              <a:defRPr sz="819"/>
            </a:lvl5pPr>
            <a:lvl6pPr marL="936117" indent="0">
              <a:buNone/>
              <a:defRPr sz="819"/>
            </a:lvl6pPr>
            <a:lvl7pPr marL="1123340" indent="0">
              <a:buNone/>
              <a:defRPr sz="819"/>
            </a:lvl7pPr>
            <a:lvl8pPr marL="1310564" indent="0">
              <a:buNone/>
              <a:defRPr sz="819"/>
            </a:lvl8pPr>
            <a:lvl9pPr marL="1497787" indent="0">
              <a:buNone/>
              <a:defRPr sz="819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8713" y="842487"/>
            <a:ext cx="2147882" cy="1560810"/>
          </a:xfrm>
        </p:spPr>
        <p:txBody>
          <a:bodyPr/>
          <a:lstStyle>
            <a:lvl1pPr marL="0" indent="0">
              <a:buNone/>
              <a:defRPr sz="655"/>
            </a:lvl1pPr>
            <a:lvl2pPr marL="187223" indent="0">
              <a:buNone/>
              <a:defRPr sz="573"/>
            </a:lvl2pPr>
            <a:lvl3pPr marL="374447" indent="0">
              <a:buNone/>
              <a:defRPr sz="491"/>
            </a:lvl3pPr>
            <a:lvl4pPr marL="561670" indent="0">
              <a:buNone/>
              <a:defRPr sz="410"/>
            </a:lvl4pPr>
            <a:lvl5pPr marL="748894" indent="0">
              <a:buNone/>
              <a:defRPr sz="410"/>
            </a:lvl5pPr>
            <a:lvl6pPr marL="936117" indent="0">
              <a:buNone/>
              <a:defRPr sz="410"/>
            </a:lvl6pPr>
            <a:lvl7pPr marL="1123340" indent="0">
              <a:buNone/>
              <a:defRPr sz="410"/>
            </a:lvl7pPr>
            <a:lvl8pPr marL="1310564" indent="0">
              <a:buNone/>
              <a:defRPr sz="410"/>
            </a:lvl8pPr>
            <a:lvl9pPr marL="1497787" indent="0">
              <a:buNone/>
              <a:defRPr sz="41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F5696F-8095-42A1-BC0E-5FCF867847FE}" type="datetimeFigureOut">
              <a:rPr lang="en-GB" smtClean="0"/>
              <a:t>31/03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11F4F-98CD-4240-8D88-1FB301D7046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312463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845" y="149515"/>
            <a:ext cx="5743873" cy="54280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845" y="747577"/>
            <a:ext cx="5743873" cy="178183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845" y="2602867"/>
            <a:ext cx="1498402" cy="14951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49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F5696F-8095-42A1-BC0E-5FCF867847FE}" type="datetimeFigureOut">
              <a:rPr lang="en-GB" smtClean="0"/>
              <a:t>31/03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05980" y="2602867"/>
            <a:ext cx="2247603" cy="14951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49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703316" y="2602867"/>
            <a:ext cx="1498402" cy="14951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49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711F4F-98CD-4240-8D88-1FB301D7046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617474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374447" rtl="0" eaLnBrk="1" latinLnBrk="0" hangingPunct="1">
        <a:lnSpc>
          <a:spcPct val="90000"/>
        </a:lnSpc>
        <a:spcBef>
          <a:spcPct val="0"/>
        </a:spcBef>
        <a:buNone/>
        <a:defRPr sz="180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93612" indent="-93612" algn="l" defTabSz="374447" rtl="0" eaLnBrk="1" latinLnBrk="0" hangingPunct="1">
        <a:lnSpc>
          <a:spcPct val="90000"/>
        </a:lnSpc>
        <a:spcBef>
          <a:spcPts val="410"/>
        </a:spcBef>
        <a:buFont typeface="Arial" panose="020B0604020202020204" pitchFamily="34" charset="0"/>
        <a:buChar char="•"/>
        <a:defRPr sz="1147" kern="1200">
          <a:solidFill>
            <a:schemeClr val="tx1"/>
          </a:solidFill>
          <a:latin typeface="+mn-lt"/>
          <a:ea typeface="+mn-ea"/>
          <a:cs typeface="+mn-cs"/>
        </a:defRPr>
      </a:lvl1pPr>
      <a:lvl2pPr marL="280835" indent="-93612" algn="l" defTabSz="374447" rtl="0" eaLnBrk="1" latinLnBrk="0" hangingPunct="1">
        <a:lnSpc>
          <a:spcPct val="90000"/>
        </a:lnSpc>
        <a:spcBef>
          <a:spcPts val="205"/>
        </a:spcBef>
        <a:buFont typeface="Arial" panose="020B0604020202020204" pitchFamily="34" charset="0"/>
        <a:buChar char="•"/>
        <a:defRPr sz="983" kern="1200">
          <a:solidFill>
            <a:schemeClr val="tx1"/>
          </a:solidFill>
          <a:latin typeface="+mn-lt"/>
          <a:ea typeface="+mn-ea"/>
          <a:cs typeface="+mn-cs"/>
        </a:defRPr>
      </a:lvl2pPr>
      <a:lvl3pPr marL="468059" indent="-93612" algn="l" defTabSz="374447" rtl="0" eaLnBrk="1" latinLnBrk="0" hangingPunct="1">
        <a:lnSpc>
          <a:spcPct val="90000"/>
        </a:lnSpc>
        <a:spcBef>
          <a:spcPts val="205"/>
        </a:spcBef>
        <a:buFont typeface="Arial" panose="020B0604020202020204" pitchFamily="34" charset="0"/>
        <a:buChar char="•"/>
        <a:defRPr sz="819" kern="1200">
          <a:solidFill>
            <a:schemeClr val="tx1"/>
          </a:solidFill>
          <a:latin typeface="+mn-lt"/>
          <a:ea typeface="+mn-ea"/>
          <a:cs typeface="+mn-cs"/>
        </a:defRPr>
      </a:lvl3pPr>
      <a:lvl4pPr marL="655282" indent="-93612" algn="l" defTabSz="374447" rtl="0" eaLnBrk="1" latinLnBrk="0" hangingPunct="1">
        <a:lnSpc>
          <a:spcPct val="90000"/>
        </a:lnSpc>
        <a:spcBef>
          <a:spcPts val="205"/>
        </a:spcBef>
        <a:buFont typeface="Arial" panose="020B0604020202020204" pitchFamily="34" charset="0"/>
        <a:buChar char="•"/>
        <a:defRPr sz="737" kern="1200">
          <a:solidFill>
            <a:schemeClr val="tx1"/>
          </a:solidFill>
          <a:latin typeface="+mn-lt"/>
          <a:ea typeface="+mn-ea"/>
          <a:cs typeface="+mn-cs"/>
        </a:defRPr>
      </a:lvl4pPr>
      <a:lvl5pPr marL="842505" indent="-93612" algn="l" defTabSz="374447" rtl="0" eaLnBrk="1" latinLnBrk="0" hangingPunct="1">
        <a:lnSpc>
          <a:spcPct val="90000"/>
        </a:lnSpc>
        <a:spcBef>
          <a:spcPts val="205"/>
        </a:spcBef>
        <a:buFont typeface="Arial" panose="020B0604020202020204" pitchFamily="34" charset="0"/>
        <a:buChar char="•"/>
        <a:defRPr sz="737" kern="1200">
          <a:solidFill>
            <a:schemeClr val="tx1"/>
          </a:solidFill>
          <a:latin typeface="+mn-lt"/>
          <a:ea typeface="+mn-ea"/>
          <a:cs typeface="+mn-cs"/>
        </a:defRPr>
      </a:lvl5pPr>
      <a:lvl6pPr marL="1029729" indent="-93612" algn="l" defTabSz="374447" rtl="0" eaLnBrk="1" latinLnBrk="0" hangingPunct="1">
        <a:lnSpc>
          <a:spcPct val="90000"/>
        </a:lnSpc>
        <a:spcBef>
          <a:spcPts val="205"/>
        </a:spcBef>
        <a:buFont typeface="Arial" panose="020B0604020202020204" pitchFamily="34" charset="0"/>
        <a:buChar char="•"/>
        <a:defRPr sz="737" kern="1200">
          <a:solidFill>
            <a:schemeClr val="tx1"/>
          </a:solidFill>
          <a:latin typeface="+mn-lt"/>
          <a:ea typeface="+mn-ea"/>
          <a:cs typeface="+mn-cs"/>
        </a:defRPr>
      </a:lvl6pPr>
      <a:lvl7pPr marL="1216952" indent="-93612" algn="l" defTabSz="374447" rtl="0" eaLnBrk="1" latinLnBrk="0" hangingPunct="1">
        <a:lnSpc>
          <a:spcPct val="90000"/>
        </a:lnSpc>
        <a:spcBef>
          <a:spcPts val="205"/>
        </a:spcBef>
        <a:buFont typeface="Arial" panose="020B0604020202020204" pitchFamily="34" charset="0"/>
        <a:buChar char="•"/>
        <a:defRPr sz="737" kern="1200">
          <a:solidFill>
            <a:schemeClr val="tx1"/>
          </a:solidFill>
          <a:latin typeface="+mn-lt"/>
          <a:ea typeface="+mn-ea"/>
          <a:cs typeface="+mn-cs"/>
        </a:defRPr>
      </a:lvl7pPr>
      <a:lvl8pPr marL="1404176" indent="-93612" algn="l" defTabSz="374447" rtl="0" eaLnBrk="1" latinLnBrk="0" hangingPunct="1">
        <a:lnSpc>
          <a:spcPct val="90000"/>
        </a:lnSpc>
        <a:spcBef>
          <a:spcPts val="205"/>
        </a:spcBef>
        <a:buFont typeface="Arial" panose="020B0604020202020204" pitchFamily="34" charset="0"/>
        <a:buChar char="•"/>
        <a:defRPr sz="737" kern="1200">
          <a:solidFill>
            <a:schemeClr val="tx1"/>
          </a:solidFill>
          <a:latin typeface="+mn-lt"/>
          <a:ea typeface="+mn-ea"/>
          <a:cs typeface="+mn-cs"/>
        </a:defRPr>
      </a:lvl8pPr>
      <a:lvl9pPr marL="1591399" indent="-93612" algn="l" defTabSz="374447" rtl="0" eaLnBrk="1" latinLnBrk="0" hangingPunct="1">
        <a:lnSpc>
          <a:spcPct val="90000"/>
        </a:lnSpc>
        <a:spcBef>
          <a:spcPts val="205"/>
        </a:spcBef>
        <a:buFont typeface="Arial" panose="020B0604020202020204" pitchFamily="34" charset="0"/>
        <a:buChar char="•"/>
        <a:defRPr sz="73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74447" rtl="0" eaLnBrk="1" latinLnBrk="0" hangingPunct="1">
        <a:defRPr sz="737" kern="1200">
          <a:solidFill>
            <a:schemeClr val="tx1"/>
          </a:solidFill>
          <a:latin typeface="+mn-lt"/>
          <a:ea typeface="+mn-ea"/>
          <a:cs typeface="+mn-cs"/>
        </a:defRPr>
      </a:lvl1pPr>
      <a:lvl2pPr marL="187223" algn="l" defTabSz="374447" rtl="0" eaLnBrk="1" latinLnBrk="0" hangingPunct="1">
        <a:defRPr sz="737" kern="1200">
          <a:solidFill>
            <a:schemeClr val="tx1"/>
          </a:solidFill>
          <a:latin typeface="+mn-lt"/>
          <a:ea typeface="+mn-ea"/>
          <a:cs typeface="+mn-cs"/>
        </a:defRPr>
      </a:lvl2pPr>
      <a:lvl3pPr marL="374447" algn="l" defTabSz="374447" rtl="0" eaLnBrk="1" latinLnBrk="0" hangingPunct="1">
        <a:defRPr sz="737" kern="1200">
          <a:solidFill>
            <a:schemeClr val="tx1"/>
          </a:solidFill>
          <a:latin typeface="+mn-lt"/>
          <a:ea typeface="+mn-ea"/>
          <a:cs typeface="+mn-cs"/>
        </a:defRPr>
      </a:lvl3pPr>
      <a:lvl4pPr marL="561670" algn="l" defTabSz="374447" rtl="0" eaLnBrk="1" latinLnBrk="0" hangingPunct="1">
        <a:defRPr sz="737" kern="1200">
          <a:solidFill>
            <a:schemeClr val="tx1"/>
          </a:solidFill>
          <a:latin typeface="+mn-lt"/>
          <a:ea typeface="+mn-ea"/>
          <a:cs typeface="+mn-cs"/>
        </a:defRPr>
      </a:lvl4pPr>
      <a:lvl5pPr marL="748894" algn="l" defTabSz="374447" rtl="0" eaLnBrk="1" latinLnBrk="0" hangingPunct="1">
        <a:defRPr sz="737" kern="1200">
          <a:solidFill>
            <a:schemeClr val="tx1"/>
          </a:solidFill>
          <a:latin typeface="+mn-lt"/>
          <a:ea typeface="+mn-ea"/>
          <a:cs typeface="+mn-cs"/>
        </a:defRPr>
      </a:lvl5pPr>
      <a:lvl6pPr marL="936117" algn="l" defTabSz="374447" rtl="0" eaLnBrk="1" latinLnBrk="0" hangingPunct="1">
        <a:defRPr sz="737" kern="1200">
          <a:solidFill>
            <a:schemeClr val="tx1"/>
          </a:solidFill>
          <a:latin typeface="+mn-lt"/>
          <a:ea typeface="+mn-ea"/>
          <a:cs typeface="+mn-cs"/>
        </a:defRPr>
      </a:lvl6pPr>
      <a:lvl7pPr marL="1123340" algn="l" defTabSz="374447" rtl="0" eaLnBrk="1" latinLnBrk="0" hangingPunct="1">
        <a:defRPr sz="737" kern="1200">
          <a:solidFill>
            <a:schemeClr val="tx1"/>
          </a:solidFill>
          <a:latin typeface="+mn-lt"/>
          <a:ea typeface="+mn-ea"/>
          <a:cs typeface="+mn-cs"/>
        </a:defRPr>
      </a:lvl7pPr>
      <a:lvl8pPr marL="1310564" algn="l" defTabSz="374447" rtl="0" eaLnBrk="1" latinLnBrk="0" hangingPunct="1">
        <a:defRPr sz="737" kern="1200">
          <a:solidFill>
            <a:schemeClr val="tx1"/>
          </a:solidFill>
          <a:latin typeface="+mn-lt"/>
          <a:ea typeface="+mn-ea"/>
          <a:cs typeface="+mn-cs"/>
        </a:defRPr>
      </a:lvl8pPr>
      <a:lvl9pPr marL="1497787" algn="l" defTabSz="374447" rtl="0" eaLnBrk="1" latinLnBrk="0" hangingPunct="1">
        <a:defRPr sz="73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图表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22841276"/>
              </p:ext>
            </p:extLst>
          </p:nvPr>
        </p:nvGraphicFramePr>
        <p:xfrm>
          <a:off x="48419" y="32544"/>
          <a:ext cx="6562724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2211684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</TotalTime>
  <Words>2</Words>
  <Application>Microsoft Office PowerPoint</Application>
  <PresentationFormat>自定义</PresentationFormat>
  <Paragraphs>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宋体</vt:lpstr>
      <vt:lpstr>Arial</vt:lpstr>
      <vt:lpstr>Calibri</vt:lpstr>
      <vt:lpstr>Calibri Light</vt:lpstr>
      <vt:lpstr>Times New Roman</vt:lpstr>
      <vt:lpstr>Office 主题</vt:lpstr>
      <vt:lpstr>PowerPoint 演示文稿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Yi Qiang</dc:creator>
  <cp:lastModifiedBy>Yi Qiang</cp:lastModifiedBy>
  <cp:revision>2</cp:revision>
  <dcterms:created xsi:type="dcterms:W3CDTF">2019-03-30T00:08:54Z</dcterms:created>
  <dcterms:modified xsi:type="dcterms:W3CDTF">2019-03-31T11:37:30Z</dcterms:modified>
</cp:coreProperties>
</file>